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58" r:id="rId5"/>
    <p:sldId id="260" r:id="rId6"/>
    <p:sldId id="263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8" autoAdjust="0"/>
    <p:restoredTop sz="94671" autoAdjust="0"/>
  </p:normalViewPr>
  <p:slideViewPr>
    <p:cSldViewPr>
      <p:cViewPr>
        <p:scale>
          <a:sx n="79" d="100"/>
          <a:sy n="79" d="100"/>
        </p:scale>
        <p:origin x="-1260" y="-5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DC0FA-8191-4DE0-ACCA-23A3E4AE22F9}" type="datetimeFigureOut">
              <a:rPr lang="en-ZA" smtClean="0"/>
              <a:t>19/02/201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731BD2-B13F-4292-89FF-841F2D4E43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062156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DC0FA-8191-4DE0-ACCA-23A3E4AE22F9}" type="datetimeFigureOut">
              <a:rPr lang="en-ZA" smtClean="0"/>
              <a:t>19/02/201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731BD2-B13F-4292-89FF-841F2D4E43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454552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DC0FA-8191-4DE0-ACCA-23A3E4AE22F9}" type="datetimeFigureOut">
              <a:rPr lang="en-ZA" smtClean="0"/>
              <a:t>19/02/201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731BD2-B13F-4292-89FF-841F2D4E43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4134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DC0FA-8191-4DE0-ACCA-23A3E4AE22F9}" type="datetimeFigureOut">
              <a:rPr lang="en-ZA" smtClean="0"/>
              <a:t>19/02/201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731BD2-B13F-4292-89FF-841F2D4E43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882404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DC0FA-8191-4DE0-ACCA-23A3E4AE22F9}" type="datetimeFigureOut">
              <a:rPr lang="en-ZA" smtClean="0"/>
              <a:t>19/02/201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731BD2-B13F-4292-89FF-841F2D4E43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726918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DC0FA-8191-4DE0-ACCA-23A3E4AE22F9}" type="datetimeFigureOut">
              <a:rPr lang="en-ZA" smtClean="0"/>
              <a:t>19/02/2016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731BD2-B13F-4292-89FF-841F2D4E43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97322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DC0FA-8191-4DE0-ACCA-23A3E4AE22F9}" type="datetimeFigureOut">
              <a:rPr lang="en-ZA" smtClean="0"/>
              <a:t>19/02/2016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731BD2-B13F-4292-89FF-841F2D4E43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970868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DC0FA-8191-4DE0-ACCA-23A3E4AE22F9}" type="datetimeFigureOut">
              <a:rPr lang="en-ZA" smtClean="0"/>
              <a:t>19/02/2016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731BD2-B13F-4292-89FF-841F2D4E43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3217349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DC0FA-8191-4DE0-ACCA-23A3E4AE22F9}" type="datetimeFigureOut">
              <a:rPr lang="en-ZA" smtClean="0"/>
              <a:t>19/02/2016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731BD2-B13F-4292-89FF-841F2D4E43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677700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DC0FA-8191-4DE0-ACCA-23A3E4AE22F9}" type="datetimeFigureOut">
              <a:rPr lang="en-ZA" smtClean="0"/>
              <a:t>19/02/2016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731BD2-B13F-4292-89FF-841F2D4E43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2008890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DC0FA-8191-4DE0-ACCA-23A3E4AE22F9}" type="datetimeFigureOut">
              <a:rPr lang="en-ZA" smtClean="0"/>
              <a:t>19/02/2016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731BD2-B13F-4292-89FF-841F2D4E43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720372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4DC0FA-8191-4DE0-ACCA-23A3E4AE22F9}" type="datetimeFigureOut">
              <a:rPr lang="en-ZA" smtClean="0"/>
              <a:t>19/02/201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731BD2-B13F-4292-89FF-841F2D4E4396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06695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0" y="5517232"/>
            <a:ext cx="9144000" cy="432048"/>
          </a:xfrm>
        </p:spPr>
        <p:txBody>
          <a:bodyPr>
            <a:noAutofit/>
          </a:bodyPr>
          <a:lstStyle/>
          <a:p>
            <a:pPr algn="l"/>
            <a:r>
              <a:rPr lang="en-ZA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ZA" sz="1400" b="1" smtClean="0">
                <a:latin typeface="Arial" panose="020B0604020202020204" pitchFamily="34" charset="0"/>
                <a:cs typeface="Arial" panose="020B0604020202020204" pitchFamily="34" charset="0"/>
              </a:rPr>
              <a:t>file 3a</a:t>
            </a:r>
            <a:r>
              <a:rPr lang="en-ZA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auve sequence alignment of ESX-P3 containing plasmids pMKMS02, pMYCSMO3 and </a:t>
            </a:r>
            <a:r>
              <a:rPr lang="en-ZA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sp</a:t>
            </a:r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MCS plasmid1 and </a:t>
            </a:r>
            <a:r>
              <a:rPr lang="en-ZA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ZA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usciae</a:t>
            </a:r>
            <a:r>
              <a:rPr lang="en-ZA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ZA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ig</a:t>
            </a:r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224.</a:t>
            </a:r>
            <a:endParaRPr lang="en-ZA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92696"/>
            <a:ext cx="9144000" cy="46904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62549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64704"/>
            <a:ext cx="9144000" cy="4690446"/>
          </a:xfrm>
          <a:prstGeom prst="rect">
            <a:avLst/>
          </a:prstGeom>
        </p:spPr>
      </p:pic>
      <p:sp>
        <p:nvSpPr>
          <p:cNvPr id="4" name="Title 1"/>
          <p:cNvSpPr txBox="1">
            <a:spLocks/>
          </p:cNvSpPr>
          <p:nvPr/>
        </p:nvSpPr>
        <p:spPr>
          <a:xfrm>
            <a:off x="0" y="5517232"/>
            <a:ext cx="9144000" cy="43204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ZA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ZA" sz="1400" b="1" smtClean="0">
                <a:latin typeface="Arial" panose="020B0604020202020204" pitchFamily="34" charset="0"/>
                <a:cs typeface="Arial" panose="020B0604020202020204" pitchFamily="34" charset="0"/>
              </a:rPr>
              <a:t>file 3b</a:t>
            </a:r>
            <a:r>
              <a:rPr lang="en-ZA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auve sequence alignment of ESX-P4 containing plasmids pMYCCH.01 and pMYCCH.02 and </a:t>
            </a:r>
            <a:r>
              <a:rPr lang="en-ZA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ZA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rascrofulaceum</a:t>
            </a:r>
            <a:r>
              <a:rPr lang="en-ZA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ntig00017.</a:t>
            </a:r>
            <a:endParaRPr lang="en-ZA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12125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82206"/>
            <a:ext cx="9144000" cy="4293588"/>
          </a:xfrm>
          <a:prstGeom prst="rect">
            <a:avLst/>
          </a:prstGeom>
        </p:spPr>
      </p:pic>
      <p:sp>
        <p:nvSpPr>
          <p:cNvPr id="5" name="Title 1"/>
          <p:cNvSpPr txBox="1">
            <a:spLocks/>
          </p:cNvSpPr>
          <p:nvPr/>
        </p:nvSpPr>
        <p:spPr>
          <a:xfrm>
            <a:off x="0" y="5608934"/>
            <a:ext cx="9144000" cy="62837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ZA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ZA" sz="1400" b="1" smtClean="0">
                <a:latin typeface="Arial" panose="020B0604020202020204" pitchFamily="34" charset="0"/>
                <a:cs typeface="Arial" panose="020B0604020202020204" pitchFamily="34" charset="0"/>
              </a:rPr>
              <a:t>file 3c</a:t>
            </a:r>
            <a:r>
              <a:rPr lang="en-ZA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auve sequence alignment of ESX-P2 containing plasmids pMKMS01, pMYCSMO1 and </a:t>
            </a:r>
            <a:r>
              <a:rPr lang="en-ZA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ZA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scessus</a:t>
            </a:r>
            <a:r>
              <a:rPr lang="en-ZA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bsp. </a:t>
            </a:r>
            <a:r>
              <a:rPr lang="en-ZA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olletii</a:t>
            </a:r>
            <a:r>
              <a:rPr lang="en-ZA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lasmid 2 and </a:t>
            </a:r>
            <a:r>
              <a:rPr lang="en-ZA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ZA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usciae</a:t>
            </a:r>
            <a:r>
              <a:rPr lang="en-ZA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ZA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igs</a:t>
            </a:r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196 and 209 and </a:t>
            </a:r>
            <a:r>
              <a:rPr lang="en-ZA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ZA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rascrofulaceum</a:t>
            </a:r>
            <a:r>
              <a:rPr lang="en-ZA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ntig00115</a:t>
            </a:r>
            <a:endParaRPr lang="en-ZA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1139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865" y="1124743"/>
            <a:ext cx="9064135" cy="4649479"/>
          </a:xfrm>
          <a:prstGeom prst="rect">
            <a:avLst/>
          </a:prstGeom>
        </p:spPr>
      </p:pic>
      <p:sp>
        <p:nvSpPr>
          <p:cNvPr id="4" name="Title 1"/>
          <p:cNvSpPr txBox="1">
            <a:spLocks/>
          </p:cNvSpPr>
          <p:nvPr/>
        </p:nvSpPr>
        <p:spPr>
          <a:xfrm>
            <a:off x="0" y="5822650"/>
            <a:ext cx="9144000" cy="43204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ZA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ZA" sz="1400" b="1" smtClean="0">
                <a:latin typeface="Arial" panose="020B0604020202020204" pitchFamily="34" charset="0"/>
                <a:cs typeface="Arial" panose="020B0604020202020204" pitchFamily="34" charset="0"/>
              </a:rPr>
              <a:t>file 3d</a:t>
            </a:r>
            <a:r>
              <a:rPr lang="en-ZA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ZA" sz="14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uve sequence alignment of ESX-P2 containing plasmid pMKMS01 and </a:t>
            </a:r>
            <a:r>
              <a:rPr lang="en-ZA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ZA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usciae</a:t>
            </a:r>
            <a:r>
              <a:rPr lang="en-ZA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ZA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igs</a:t>
            </a:r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196 and 209</a:t>
            </a:r>
            <a:endParaRPr lang="en-ZA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12125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865" y="1124744"/>
            <a:ext cx="8984270" cy="4608512"/>
          </a:xfrm>
          <a:prstGeom prst="rect">
            <a:avLst/>
          </a:prstGeom>
        </p:spPr>
      </p:pic>
      <p:sp>
        <p:nvSpPr>
          <p:cNvPr id="5" name="Title 1"/>
          <p:cNvSpPr txBox="1">
            <a:spLocks/>
          </p:cNvSpPr>
          <p:nvPr/>
        </p:nvSpPr>
        <p:spPr>
          <a:xfrm>
            <a:off x="0" y="5839637"/>
            <a:ext cx="9144000" cy="43204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ZA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ZA" sz="1400" b="1" smtClean="0">
                <a:latin typeface="Arial" panose="020B0604020202020204" pitchFamily="34" charset="0"/>
                <a:cs typeface="Arial" panose="020B0604020202020204" pitchFamily="34" charset="0"/>
              </a:rPr>
              <a:t>file 3e</a:t>
            </a:r>
            <a:r>
              <a:rPr lang="en-ZA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auve sequence alignment of ESX-P2 containing plasmids pMYCSMO1 and </a:t>
            </a:r>
            <a:r>
              <a:rPr lang="en-ZA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ZA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bscessus</a:t>
            </a:r>
            <a:r>
              <a:rPr lang="en-ZA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bsp. </a:t>
            </a:r>
            <a:r>
              <a:rPr lang="en-ZA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olletii</a:t>
            </a:r>
            <a:r>
              <a:rPr lang="en-ZA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lasmid 2 and </a:t>
            </a:r>
            <a:r>
              <a:rPr lang="en-ZA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ZA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rascrofulaceum</a:t>
            </a:r>
            <a:r>
              <a:rPr lang="en-ZA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ntig00115</a:t>
            </a:r>
            <a:endParaRPr lang="en-ZA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29619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48680"/>
            <a:ext cx="9144000" cy="4293588"/>
          </a:xfrm>
          <a:prstGeom prst="rect">
            <a:avLst/>
          </a:prstGeom>
        </p:spPr>
      </p:pic>
      <p:sp>
        <p:nvSpPr>
          <p:cNvPr id="5" name="Title 1"/>
          <p:cNvSpPr txBox="1">
            <a:spLocks/>
          </p:cNvSpPr>
          <p:nvPr/>
        </p:nvSpPr>
        <p:spPr>
          <a:xfrm>
            <a:off x="18316" y="5157192"/>
            <a:ext cx="9144000" cy="43204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ZA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ZA" sz="1400" b="1" smtClean="0">
                <a:latin typeface="Arial" panose="020B0604020202020204" pitchFamily="34" charset="0"/>
                <a:cs typeface="Arial" panose="020B0604020202020204" pitchFamily="34" charset="0"/>
              </a:rPr>
              <a:t>file 3f</a:t>
            </a:r>
            <a:r>
              <a:rPr lang="en-ZA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auve sequence alignment of ESX-P5 containing plasmids pMyong1, </a:t>
            </a:r>
            <a:r>
              <a:rPr lang="en-ZA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AH</a:t>
            </a:r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ZA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AW</a:t>
            </a:r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and pMK12478 and </a:t>
            </a:r>
            <a:r>
              <a:rPr lang="en-ZA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ZA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rascrofulaceum</a:t>
            </a:r>
            <a:r>
              <a:rPr lang="en-ZA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ZA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ontig109</a:t>
            </a:r>
            <a:endParaRPr lang="en-ZA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84848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653</TotalTime>
  <Words>153</Words>
  <Application>Microsoft Office PowerPoint</Application>
  <PresentationFormat>On-screen Show (4:3)</PresentationFormat>
  <Paragraphs>6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Additional file 3a. Mauve sequence alignment of ESX-P3 containing plasmids pMKMS02, pMYCSMO3 and M. sp. MCS plasmid1 and M. tusciae contig 224.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SX-P3</dc:title>
  <dc:creator>Mae Newton-Foot</dc:creator>
  <cp:lastModifiedBy>Mae Newton-Foot</cp:lastModifiedBy>
  <cp:revision>22</cp:revision>
  <dcterms:created xsi:type="dcterms:W3CDTF">2013-09-10T06:03:39Z</dcterms:created>
  <dcterms:modified xsi:type="dcterms:W3CDTF">2016-02-19T08:26:22Z</dcterms:modified>
</cp:coreProperties>
</file>